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441473" y="2685522"/>
            <a:ext cx="5021109" cy="392263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32236" y="6722075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OS in patients with different tumor cell differentiation.  Log-rank test demonstrated no significant association between OS and tumor cell differentiat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2257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3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4</cp:revision>
  <cp:lastPrinted>2015-04-23T21:25:43Z</cp:lastPrinted>
  <dcterms:created xsi:type="dcterms:W3CDTF">2015-04-23T20:59:46Z</dcterms:created>
  <dcterms:modified xsi:type="dcterms:W3CDTF">2015-05-29T02:16:23Z</dcterms:modified>
</cp:coreProperties>
</file>